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115" d="100"/>
          <a:sy n="115" d="100"/>
        </p:scale>
        <p:origin x="372" y="11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fr-FR" smtClean="0"/>
              <a:t>Modifier le style des sous-titres du masque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197F0B-8B66-4C54-91FD-95BDA12FA3AF}" type="datetimeFigureOut">
              <a:rPr lang="fr-FR" smtClean="0"/>
              <a:t>10/10/2022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6561CB-7B2B-4C4F-8218-E827804CB964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77795978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197F0B-8B66-4C54-91FD-95BDA12FA3AF}" type="datetimeFigureOut">
              <a:rPr lang="fr-FR" smtClean="0"/>
              <a:t>10/10/2022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6561CB-7B2B-4C4F-8218-E827804CB964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91393348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197F0B-8B66-4C54-91FD-95BDA12FA3AF}" type="datetimeFigureOut">
              <a:rPr lang="fr-FR" smtClean="0"/>
              <a:t>10/10/2022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6561CB-7B2B-4C4F-8218-E827804CB964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84383943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197F0B-8B66-4C54-91FD-95BDA12FA3AF}" type="datetimeFigureOut">
              <a:rPr lang="fr-FR" smtClean="0"/>
              <a:t>10/10/2022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6561CB-7B2B-4C4F-8218-E827804CB964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28545792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197F0B-8B66-4C54-91FD-95BDA12FA3AF}" type="datetimeFigureOut">
              <a:rPr lang="fr-FR" smtClean="0"/>
              <a:t>10/10/2022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6561CB-7B2B-4C4F-8218-E827804CB964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84127085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197F0B-8B66-4C54-91FD-95BDA12FA3AF}" type="datetimeFigureOut">
              <a:rPr lang="fr-FR" smtClean="0"/>
              <a:t>10/10/2022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6561CB-7B2B-4C4F-8218-E827804CB964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99719252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197F0B-8B66-4C54-91FD-95BDA12FA3AF}" type="datetimeFigureOut">
              <a:rPr lang="fr-FR" smtClean="0"/>
              <a:t>10/10/2022</a:t>
            </a:fld>
            <a:endParaRPr lang="fr-FR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6561CB-7B2B-4C4F-8218-E827804CB964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29708054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197F0B-8B66-4C54-91FD-95BDA12FA3AF}" type="datetimeFigureOut">
              <a:rPr lang="fr-FR" smtClean="0"/>
              <a:t>10/10/2022</a:t>
            </a:fld>
            <a:endParaRPr lang="fr-FR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6561CB-7B2B-4C4F-8218-E827804CB964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02787773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197F0B-8B66-4C54-91FD-95BDA12FA3AF}" type="datetimeFigureOut">
              <a:rPr lang="fr-FR" smtClean="0"/>
              <a:t>10/10/2022</a:t>
            </a:fld>
            <a:endParaRPr lang="fr-FR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6561CB-7B2B-4C4F-8218-E827804CB964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95872235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197F0B-8B66-4C54-91FD-95BDA12FA3AF}" type="datetimeFigureOut">
              <a:rPr lang="fr-FR" smtClean="0"/>
              <a:t>10/10/2022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6561CB-7B2B-4C4F-8218-E827804CB964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37620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pour une image 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197F0B-8B66-4C54-91FD-95BDA12FA3AF}" type="datetimeFigureOut">
              <a:rPr lang="fr-FR" smtClean="0"/>
              <a:t>10/10/2022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6561CB-7B2B-4C4F-8218-E827804CB964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66453832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3197F0B-8B66-4C54-91FD-95BDA12FA3AF}" type="datetimeFigureOut">
              <a:rPr lang="fr-FR" smtClean="0"/>
              <a:t>10/10/2022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66561CB-7B2B-4C4F-8218-E827804CB964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91000113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f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ZoneTexte 7"/>
          <p:cNvSpPr txBox="1"/>
          <p:nvPr/>
        </p:nvSpPr>
        <p:spPr>
          <a:xfrm>
            <a:off x="527481" y="378750"/>
            <a:ext cx="49045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b="1" dirty="0" smtClean="0"/>
              <a:t>A</a:t>
            </a:r>
            <a:endParaRPr lang="fr-FR" b="1" dirty="0"/>
          </a:p>
        </p:txBody>
      </p:sp>
      <p:sp>
        <p:nvSpPr>
          <p:cNvPr id="9" name="ZoneTexte 8"/>
          <p:cNvSpPr txBox="1"/>
          <p:nvPr/>
        </p:nvSpPr>
        <p:spPr>
          <a:xfrm>
            <a:off x="6042977" y="378750"/>
            <a:ext cx="49045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b="1" dirty="0"/>
              <a:t>B</a:t>
            </a:r>
          </a:p>
        </p:txBody>
      </p:sp>
      <p:pic>
        <p:nvPicPr>
          <p:cNvPr id="10" name="Image 9"/>
          <p:cNvPicPr/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437833" y="644205"/>
            <a:ext cx="5120640" cy="5062450"/>
          </a:xfrm>
          <a:prstGeom prst="rect">
            <a:avLst/>
          </a:prstGeom>
        </p:spPr>
      </p:pic>
      <p:pic>
        <p:nvPicPr>
          <p:cNvPr id="11" name="Image 10" descr="C:\Users\ledorma191\Documents\THESE\WP2\ACP\MRS 25°C\Fichier OK\MRS25 T96.tif"/>
          <p:cNvPicPr/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65019" y="748082"/>
            <a:ext cx="5037512" cy="4854696"/>
          </a:xfrm>
          <a:prstGeom prst="rect">
            <a:avLst/>
          </a:prstGeom>
          <a:noFill/>
          <a:ln>
            <a:noFill/>
          </a:ln>
        </p:spPr>
      </p:pic>
      <p:sp>
        <p:nvSpPr>
          <p:cNvPr id="2" name="Rectangle 1"/>
          <p:cNvSpPr/>
          <p:nvPr/>
        </p:nvSpPr>
        <p:spPr>
          <a:xfrm>
            <a:off x="651799" y="5602778"/>
            <a:ext cx="10964487" cy="101438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07000"/>
              </a:lnSpc>
              <a:spcAft>
                <a:spcPts val="800"/>
              </a:spcAft>
              <a:tabLst>
                <a:tab pos="861060" algn="l"/>
              </a:tabLst>
            </a:pPr>
            <a:r>
              <a:rPr lang="en-US" sz="1400" b="1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Figure </a:t>
            </a:r>
            <a:r>
              <a:rPr lang="en-US" sz="1400" b="1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3</a:t>
            </a:r>
            <a:r>
              <a:rPr lang="en-US" sz="140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: </a:t>
            </a:r>
            <a:r>
              <a:rPr lang="en-US" sz="14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(A) Principal Component Analysis of the studied compounds (black arrows) with illustrative variables representing the four strains of the model (red arrows). (B) Distribution of the samples in condition C (control), D </a:t>
            </a:r>
            <a:r>
              <a:rPr lang="en-US" sz="1400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(disturbance </a:t>
            </a:r>
            <a:r>
              <a:rPr lang="en-US" sz="14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without phages) and P </a:t>
            </a:r>
            <a:r>
              <a:rPr lang="en-US" sz="1400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(disturbance </a:t>
            </a:r>
            <a:r>
              <a:rPr lang="en-US" sz="14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with phages) at 96h for the experiment at 25°C. Samples are named as follows: Condition (C: control, D: </a:t>
            </a:r>
            <a:r>
              <a:rPr lang="en-US" sz="1400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disturbance </a:t>
            </a:r>
            <a:r>
              <a:rPr lang="en-US" sz="14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without phages, P: </a:t>
            </a:r>
            <a:r>
              <a:rPr lang="en-US" sz="1400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disturbance </a:t>
            </a:r>
            <a:r>
              <a:rPr lang="en-US" sz="14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with phages). Time point (0, 48h, 72h, 96h, 168h). Biological replicate (1, 2, 3) (e.g. C96_1 means Control at 96h, biological replicate 1).</a:t>
            </a:r>
            <a:endParaRPr lang="fr-FR" sz="14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931888068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</TotalTime>
  <Words>126</Words>
  <Application>Microsoft Office PowerPoint</Application>
  <PresentationFormat>Grand écran</PresentationFormat>
  <Paragraphs>3</Paragraphs>
  <Slides>1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4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Thème Office</vt:lpstr>
      <vt:lpstr>Présentation PowerPoint</vt:lpstr>
    </vt:vector>
  </TitlesOfParts>
  <Company>_x000d_
			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Pierre Ledormand</dc:creator>
  <cp:lastModifiedBy>Pierre Ledormand</cp:lastModifiedBy>
  <cp:revision>8</cp:revision>
  <dcterms:created xsi:type="dcterms:W3CDTF">2022-07-22T12:25:17Z</dcterms:created>
  <dcterms:modified xsi:type="dcterms:W3CDTF">2022-10-10T14:15:50Z</dcterms:modified>
</cp:coreProperties>
</file>